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4" r:id="rId2"/>
    <p:sldId id="278" r:id="rId3"/>
    <p:sldId id="277" r:id="rId4"/>
    <p:sldId id="272" r:id="rId5"/>
    <p:sldId id="275" r:id="rId6"/>
    <p:sldId id="279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718"/>
    <p:restoredTop sz="96327"/>
  </p:normalViewPr>
  <p:slideViewPr>
    <p:cSldViewPr snapToGrid="0">
      <p:cViewPr varScale="1">
        <p:scale>
          <a:sx n="155" d="100"/>
          <a:sy n="155" d="100"/>
        </p:scale>
        <p:origin x="627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69E98-92CD-424B-9498-43B3A49FFD97}" type="datetimeFigureOut">
              <a:rPr lang="fr-FR" smtClean="0"/>
              <a:t>12/03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A59DF-E2A3-2641-9FC0-F6E836D13A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8398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69E98-92CD-424B-9498-43B3A49FFD97}" type="datetimeFigureOut">
              <a:rPr lang="fr-FR" smtClean="0"/>
              <a:t>12/03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A59DF-E2A3-2641-9FC0-F6E836D13A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09830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69E98-92CD-424B-9498-43B3A49FFD97}" type="datetimeFigureOut">
              <a:rPr lang="fr-FR" smtClean="0"/>
              <a:t>12/03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A59DF-E2A3-2641-9FC0-F6E836D13A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37876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69E98-92CD-424B-9498-43B3A49FFD97}" type="datetimeFigureOut">
              <a:rPr lang="fr-FR" smtClean="0"/>
              <a:t>12/03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A59DF-E2A3-2641-9FC0-F6E836D13A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31940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69E98-92CD-424B-9498-43B3A49FFD97}" type="datetimeFigureOut">
              <a:rPr lang="fr-FR" smtClean="0"/>
              <a:t>12/03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A59DF-E2A3-2641-9FC0-F6E836D13A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17158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69E98-92CD-424B-9498-43B3A49FFD97}" type="datetimeFigureOut">
              <a:rPr lang="fr-FR" smtClean="0"/>
              <a:t>12/03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A59DF-E2A3-2641-9FC0-F6E836D13A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44562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69E98-92CD-424B-9498-43B3A49FFD97}" type="datetimeFigureOut">
              <a:rPr lang="fr-FR" smtClean="0"/>
              <a:t>12/03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A59DF-E2A3-2641-9FC0-F6E836D13A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16058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69E98-92CD-424B-9498-43B3A49FFD97}" type="datetimeFigureOut">
              <a:rPr lang="fr-FR" smtClean="0"/>
              <a:t>12/03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A59DF-E2A3-2641-9FC0-F6E836D13A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01701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69E98-92CD-424B-9498-43B3A49FFD97}" type="datetimeFigureOut">
              <a:rPr lang="fr-FR" smtClean="0"/>
              <a:t>12/03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A59DF-E2A3-2641-9FC0-F6E836D13A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699680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69E98-92CD-424B-9498-43B3A49FFD97}" type="datetimeFigureOut">
              <a:rPr lang="fr-FR" smtClean="0"/>
              <a:t>12/03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A59DF-E2A3-2641-9FC0-F6E836D13A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2410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69E98-92CD-424B-9498-43B3A49FFD97}" type="datetimeFigureOut">
              <a:rPr lang="fr-FR" smtClean="0"/>
              <a:t>12/03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A59DF-E2A3-2641-9FC0-F6E836D13A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57273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469E98-92CD-424B-9498-43B3A49FFD97}" type="datetimeFigureOut">
              <a:rPr lang="fr-FR" smtClean="0"/>
              <a:t>12/03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7A59DF-E2A3-2641-9FC0-F6E836D13A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021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Espace réservé du contenu 3">
            <a:extLst>
              <a:ext uri="{FF2B5EF4-FFF2-40B4-BE49-F238E27FC236}">
                <a16:creationId xmlns:a16="http://schemas.microsoft.com/office/drawing/2014/main" id="{5CF16EF4-8E26-AE40-BFC3-C5FB57E3E413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342900" y="1583390"/>
          <a:ext cx="6172201" cy="259588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881743">
                  <a:extLst>
                    <a:ext uri="{9D8B030D-6E8A-4147-A177-3AD203B41FA5}">
                      <a16:colId xmlns:a16="http://schemas.microsoft.com/office/drawing/2014/main" val="3808057059"/>
                    </a:ext>
                  </a:extLst>
                </a:gridCol>
                <a:gridCol w="881743">
                  <a:extLst>
                    <a:ext uri="{9D8B030D-6E8A-4147-A177-3AD203B41FA5}">
                      <a16:colId xmlns:a16="http://schemas.microsoft.com/office/drawing/2014/main" val="1640201251"/>
                    </a:ext>
                  </a:extLst>
                </a:gridCol>
                <a:gridCol w="881743">
                  <a:extLst>
                    <a:ext uri="{9D8B030D-6E8A-4147-A177-3AD203B41FA5}">
                      <a16:colId xmlns:a16="http://schemas.microsoft.com/office/drawing/2014/main" val="3492830122"/>
                    </a:ext>
                  </a:extLst>
                </a:gridCol>
                <a:gridCol w="881743">
                  <a:extLst>
                    <a:ext uri="{9D8B030D-6E8A-4147-A177-3AD203B41FA5}">
                      <a16:colId xmlns:a16="http://schemas.microsoft.com/office/drawing/2014/main" val="1011963937"/>
                    </a:ext>
                  </a:extLst>
                </a:gridCol>
                <a:gridCol w="881743">
                  <a:extLst>
                    <a:ext uri="{9D8B030D-6E8A-4147-A177-3AD203B41FA5}">
                      <a16:colId xmlns:a16="http://schemas.microsoft.com/office/drawing/2014/main" val="784433216"/>
                    </a:ext>
                  </a:extLst>
                </a:gridCol>
                <a:gridCol w="881743">
                  <a:extLst>
                    <a:ext uri="{9D8B030D-6E8A-4147-A177-3AD203B41FA5}">
                      <a16:colId xmlns:a16="http://schemas.microsoft.com/office/drawing/2014/main" val="3142804248"/>
                    </a:ext>
                  </a:extLst>
                </a:gridCol>
                <a:gridCol w="881743">
                  <a:extLst>
                    <a:ext uri="{9D8B030D-6E8A-4147-A177-3AD203B41FA5}">
                      <a16:colId xmlns:a16="http://schemas.microsoft.com/office/drawing/2014/main" val="388008114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fontAlgn="b"/>
                      <a:endParaRPr lang="fr-FR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P1</a:t>
                      </a:r>
                      <a:endParaRPr lang="fr-FR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solidFill>
                            <a:schemeClr val="tx1"/>
                          </a:solidFill>
                          <a:effectLst/>
                        </a:rPr>
                        <a:t>P7</a:t>
                      </a:r>
                      <a:endParaRPr lang="fr-FR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P14</a:t>
                      </a:r>
                      <a:endParaRPr lang="fr-FR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4262795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endParaRPr lang="fr-FR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Ctl</a:t>
                      </a:r>
                      <a:endParaRPr lang="fr-FR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iNO</a:t>
                      </a:r>
                      <a:endParaRPr lang="fr-FR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Ctl</a:t>
                      </a:r>
                      <a:endParaRPr lang="fr-FR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iNO</a:t>
                      </a:r>
                      <a:endParaRPr lang="fr-FR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Ctl</a:t>
                      </a:r>
                      <a:endParaRPr lang="fr-FR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iNO</a:t>
                      </a:r>
                      <a:endParaRPr lang="fr-FR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366365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1" u="none" strike="noStrike" dirty="0" err="1">
                          <a:effectLst/>
                        </a:rPr>
                        <a:t>Hb</a:t>
                      </a:r>
                      <a:r>
                        <a:rPr lang="fr-FR" sz="1000" b="1" u="none" strike="noStrike" dirty="0">
                          <a:effectLst/>
                        </a:rPr>
                        <a:t> </a:t>
                      </a:r>
                      <a:r>
                        <a:rPr lang="fr-FR" sz="1000" b="0" u="none" strike="noStrike" dirty="0">
                          <a:effectLst/>
                        </a:rPr>
                        <a:t>(g/</a:t>
                      </a:r>
                      <a:r>
                        <a:rPr lang="fr-FR" sz="1000" b="0" u="none" strike="noStrike" dirty="0" err="1">
                          <a:effectLst/>
                        </a:rPr>
                        <a:t>dL</a:t>
                      </a:r>
                      <a:r>
                        <a:rPr lang="fr-FR" sz="1000" b="0" u="none" strike="noStrike" dirty="0">
                          <a:effectLst/>
                        </a:rPr>
                        <a:t>)</a:t>
                      </a:r>
                      <a:endParaRPr lang="fr-FR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10,97 ± 0,78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11,42 ± 0,61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8,92 ± 0,68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 dirty="0">
                          <a:effectLst/>
                        </a:rPr>
                        <a:t>9,96 ± 0,36 *</a:t>
                      </a:r>
                      <a:endParaRPr lang="fr-FR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9,92 ± 0,43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 dirty="0">
                          <a:effectLst/>
                        </a:rPr>
                        <a:t>9,97 ± 0,39</a:t>
                      </a:r>
                      <a:endParaRPr lang="fr-FR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140356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1" u="none" strike="noStrike" dirty="0" err="1">
                          <a:effectLst/>
                        </a:rPr>
                        <a:t>MetHb</a:t>
                      </a:r>
                      <a:r>
                        <a:rPr lang="fr-FR" sz="1000" b="1" u="none" strike="noStrike" dirty="0">
                          <a:effectLst/>
                        </a:rPr>
                        <a:t> </a:t>
                      </a:r>
                      <a:r>
                        <a:rPr lang="fr-FR" sz="1000" b="0" u="none" strike="noStrike" dirty="0">
                          <a:effectLst/>
                        </a:rPr>
                        <a:t>(%)</a:t>
                      </a:r>
                      <a:endParaRPr lang="fr-FR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>
                      <a:noFill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0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0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0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0,03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0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 dirty="0">
                          <a:effectLst/>
                        </a:rPr>
                        <a:t>0</a:t>
                      </a:r>
                      <a:endParaRPr lang="fr-FR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471487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1" u="none" strike="noStrike" dirty="0">
                          <a:effectLst/>
                        </a:rPr>
                        <a:t>PaCO2 </a:t>
                      </a:r>
                      <a:r>
                        <a:rPr lang="fr-FR" sz="1000" b="0" u="none" strike="noStrike" dirty="0">
                          <a:effectLst/>
                        </a:rPr>
                        <a:t>(</a:t>
                      </a:r>
                      <a:r>
                        <a:rPr lang="fr-FR" sz="1000" b="0" u="none" strike="noStrike" dirty="0" err="1">
                          <a:effectLst/>
                        </a:rPr>
                        <a:t>mmHg</a:t>
                      </a:r>
                      <a:r>
                        <a:rPr lang="fr-FR" sz="1000" b="0" u="none" strike="noStrike" dirty="0">
                          <a:effectLst/>
                        </a:rPr>
                        <a:t>)</a:t>
                      </a:r>
                      <a:endParaRPr lang="fr-FR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48,62 ± 4,73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 dirty="0">
                          <a:effectLst/>
                        </a:rPr>
                        <a:t>41,92 ± 2,98 *</a:t>
                      </a:r>
                      <a:endParaRPr lang="fr-FR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46,28 ± 5,41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42,56 ± 2,24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35,25 ± 9,36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 dirty="0">
                          <a:effectLst/>
                        </a:rPr>
                        <a:t>43,68 ± 2,84</a:t>
                      </a:r>
                      <a:endParaRPr lang="fr-FR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9170315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1" u="none" strike="noStrike" dirty="0">
                          <a:effectLst/>
                        </a:rPr>
                        <a:t>PaO2 </a:t>
                      </a:r>
                      <a:r>
                        <a:rPr lang="fr-FR" sz="1000" b="0" u="none" strike="noStrike" dirty="0">
                          <a:effectLst/>
                        </a:rPr>
                        <a:t>(</a:t>
                      </a:r>
                      <a:r>
                        <a:rPr lang="fr-FR" sz="1000" b="0" u="none" strike="noStrike" dirty="0" err="1">
                          <a:effectLst/>
                        </a:rPr>
                        <a:t>mmHg</a:t>
                      </a:r>
                      <a:r>
                        <a:rPr lang="fr-FR" sz="1000" b="0" u="none" strike="noStrike" dirty="0">
                          <a:effectLst/>
                        </a:rPr>
                        <a:t>)</a:t>
                      </a:r>
                      <a:endParaRPr lang="fr-FR" sz="10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47,61 ± 9,17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52,37 ± 6,30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49,6 ± 5,21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54,64 ± 9,47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54,85 ± 12,28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 dirty="0">
                          <a:effectLst/>
                        </a:rPr>
                        <a:t>48,4 ± 7,52</a:t>
                      </a:r>
                      <a:endParaRPr lang="fr-FR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844437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b="1" u="none" strike="noStrike" dirty="0">
                          <a:effectLst/>
                        </a:rPr>
                        <a:t>pH</a:t>
                      </a:r>
                      <a:endParaRPr lang="fr-FR" sz="10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7,42 ± 0,03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7,45 ± 0,034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7,43 ± 0,04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 dirty="0">
                          <a:effectLst/>
                        </a:rPr>
                        <a:t>7,36 ± 0,13</a:t>
                      </a:r>
                      <a:endParaRPr lang="fr-FR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 dirty="0">
                          <a:effectLst/>
                        </a:rPr>
                        <a:t>7,43 ± 0,07</a:t>
                      </a:r>
                      <a:endParaRPr lang="fr-FR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 dirty="0">
                          <a:effectLst/>
                        </a:rPr>
                        <a:t>7,17 ± 0,16 **</a:t>
                      </a:r>
                      <a:endParaRPr lang="fr-FR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9362207"/>
                  </a:ext>
                </a:extLst>
              </a:tr>
            </a:tbl>
          </a:graphicData>
        </a:graphic>
      </p:graphicFrame>
      <p:sp>
        <p:nvSpPr>
          <p:cNvPr id="2" name="TextBox 14">
            <a:extLst>
              <a:ext uri="{FF2B5EF4-FFF2-40B4-BE49-F238E27FC236}">
                <a16:creationId xmlns:a16="http://schemas.microsoft.com/office/drawing/2014/main" id="{940EF013-5F5B-430A-6FE0-C928ABE118E9}"/>
              </a:ext>
            </a:extLst>
          </p:cNvPr>
          <p:cNvSpPr txBox="1"/>
          <p:nvPr/>
        </p:nvSpPr>
        <p:spPr>
          <a:xfrm>
            <a:off x="342899" y="4455720"/>
            <a:ext cx="617220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cs typeface="Times New Roman" panose="02020603050405020304" pitchFamily="18" charset="0"/>
              </a:rPr>
              <a:t>Supplemental Table S1: Arterial </a:t>
            </a:r>
            <a:r>
              <a:rPr lang="en-US" sz="1000" b="1" dirty="0" err="1">
                <a:cs typeface="Times New Roman" panose="02020603050405020304" pitchFamily="18" charset="0"/>
              </a:rPr>
              <a:t>gazometry</a:t>
            </a:r>
            <a:r>
              <a:rPr lang="en-US" sz="1000" b="1" dirty="0">
                <a:cs typeface="Times New Roman" panose="02020603050405020304" pitchFamily="18" charset="0"/>
              </a:rPr>
              <a:t> in rat pups exposed to inhaled NO 5 ppm or room air at P1, P7 and P14.</a:t>
            </a:r>
            <a:endParaRPr lang="en-US" sz="1000" b="1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US" sz="1000" dirty="0">
                <a:cs typeface="Times New Roman" panose="02020603050405020304" pitchFamily="18" charset="0"/>
              </a:rPr>
              <a:t>Student’s t-test: * and ** compared to </a:t>
            </a:r>
            <a:r>
              <a:rPr lang="en-US" sz="1000" dirty="0" err="1">
                <a:cs typeface="Times New Roman" panose="02020603050405020304" pitchFamily="18" charset="0"/>
              </a:rPr>
              <a:t>Ctl</a:t>
            </a:r>
            <a:r>
              <a:rPr lang="en-US" sz="1000" dirty="0">
                <a:cs typeface="Times New Roman" panose="02020603050405020304" pitchFamily="18" charset="0"/>
              </a:rPr>
              <a:t> means p &lt;0.05 and &lt;0.01, respectively.</a:t>
            </a:r>
          </a:p>
        </p:txBody>
      </p:sp>
    </p:spTree>
    <p:extLst>
      <p:ext uri="{BB962C8B-B14F-4D97-AF65-F5344CB8AC3E}">
        <p14:creationId xmlns:p14="http://schemas.microsoft.com/office/powerpoint/2010/main" val="40336771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4">
            <a:extLst>
              <a:ext uri="{FF2B5EF4-FFF2-40B4-BE49-F238E27FC236}">
                <a16:creationId xmlns:a16="http://schemas.microsoft.com/office/drawing/2014/main" id="{940EF013-5F5B-430A-6FE0-C928ABE118E9}"/>
              </a:ext>
            </a:extLst>
          </p:cNvPr>
          <p:cNvSpPr txBox="1"/>
          <p:nvPr/>
        </p:nvSpPr>
        <p:spPr>
          <a:xfrm>
            <a:off x="342899" y="4455720"/>
            <a:ext cx="61722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cs typeface="Times New Roman" panose="02020603050405020304" pitchFamily="18" charset="0"/>
              </a:rPr>
              <a:t>Supplemental Table S2: List of antibodies used for immunohistochemistry and Western blotting.</a:t>
            </a:r>
            <a:endParaRPr lang="en-US" sz="1000" dirty="0">
              <a:cs typeface="Times New Roman" panose="02020603050405020304" pitchFamily="18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8723E06C-A923-36A7-8086-856F321F6FE4}"/>
              </a:ext>
            </a:extLst>
          </p:cNvPr>
          <p:cNvSpPr txBox="1"/>
          <p:nvPr/>
        </p:nvSpPr>
        <p:spPr>
          <a:xfrm>
            <a:off x="642551" y="889686"/>
            <a:ext cx="3877985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cs typeface="Times New Roman"/>
              </a:rPr>
              <a:t>			</a:t>
            </a:r>
          </a:p>
          <a:p>
            <a:r>
              <a:rPr lang="en-US" sz="1000" dirty="0">
                <a:cs typeface="Times New Roman"/>
              </a:rPr>
              <a:t>	</a:t>
            </a:r>
          </a:p>
          <a:p>
            <a:r>
              <a:rPr lang="en-US" sz="1000" dirty="0">
                <a:cs typeface="Times New Roman"/>
              </a:rPr>
              <a:t>		 						</a:t>
            </a:r>
            <a:endParaRPr lang="fr-FR" sz="1000" dirty="0"/>
          </a:p>
        </p:txBody>
      </p:sp>
      <p:graphicFrame>
        <p:nvGraphicFramePr>
          <p:cNvPr id="3" name="Tableau 3">
            <a:extLst>
              <a:ext uri="{FF2B5EF4-FFF2-40B4-BE49-F238E27FC236}">
                <a16:creationId xmlns:a16="http://schemas.microsoft.com/office/drawing/2014/main" id="{B1A235DC-703A-8696-8DF5-5450102755D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05968065"/>
              </p:ext>
            </p:extLst>
          </p:nvPr>
        </p:nvGraphicFramePr>
        <p:xfrm>
          <a:off x="342900" y="1443684"/>
          <a:ext cx="6172202" cy="2062974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2321923">
                  <a:extLst>
                    <a:ext uri="{9D8B030D-6E8A-4147-A177-3AD203B41FA5}">
                      <a16:colId xmlns:a16="http://schemas.microsoft.com/office/drawing/2014/main" val="24877163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2969468678"/>
                    </a:ext>
                  </a:extLst>
                </a:gridCol>
                <a:gridCol w="3118759">
                  <a:extLst>
                    <a:ext uri="{9D8B030D-6E8A-4147-A177-3AD203B41FA5}">
                      <a16:colId xmlns:a16="http://schemas.microsoft.com/office/drawing/2014/main" val="4180015600"/>
                    </a:ext>
                  </a:extLst>
                </a:gridCol>
              </a:tblGrid>
              <a:tr h="235456">
                <a:tc>
                  <a:txBody>
                    <a:bodyPr/>
                    <a:lstStyle/>
                    <a:p>
                      <a:r>
                        <a:rPr lang="en-US" sz="1000" dirty="0">
                          <a:cs typeface="Times New Roman"/>
                        </a:rPr>
                        <a:t>Antibody	</a:t>
                      </a:r>
                      <a:endParaRPr lang="fr-FR" sz="1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fr-FR" sz="1000" dirty="0"/>
                        <a:t>Dilution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>
                          <a:cs typeface="Times New Roman"/>
                        </a:rPr>
                        <a:t>Reference</a:t>
                      </a:r>
                      <a:endParaRPr lang="fr-FR" sz="1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73366849"/>
                  </a:ext>
                </a:extLst>
              </a:tr>
              <a:tr h="315207">
                <a:tc>
                  <a:txBody>
                    <a:bodyPr/>
                    <a:lstStyle/>
                    <a:p>
                      <a:r>
                        <a:rPr lang="en-US" sz="1000" dirty="0">
                          <a:cs typeface="Times New Roman"/>
                        </a:rPr>
                        <a:t>Monocarboxylate Transporter 1 (MCT-1)</a:t>
                      </a:r>
                      <a:endParaRPr lang="fr-FR" sz="1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fr-FR" sz="1000" dirty="0"/>
                        <a:t>1/500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>
                          <a:cs typeface="Times New Roman"/>
                        </a:rPr>
                        <a:t>MAB3540 Chemicon</a:t>
                      </a:r>
                      <a:r>
                        <a:rPr lang="en-US" sz="1000" dirty="0">
                          <a:cs typeface="Times New Roman"/>
                        </a:rPr>
                        <a:t> Int, Temecula, CA</a:t>
                      </a:r>
                      <a:endParaRPr lang="fr-FR" sz="1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157972"/>
                  </a:ext>
                </a:extLst>
              </a:tr>
              <a:tr h="315207">
                <a:tc>
                  <a:txBody>
                    <a:bodyPr/>
                    <a:lstStyle/>
                    <a:p>
                      <a:r>
                        <a:rPr lang="en-US" sz="1000" dirty="0">
                          <a:cs typeface="Times New Roman"/>
                        </a:rPr>
                        <a:t>Neuronal Nitric Oxide Synthase/NOS1 </a:t>
                      </a:r>
                      <a:endParaRPr lang="fr-FR" sz="1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dirty="0"/>
                        <a:t>1/2000e</a:t>
                      </a:r>
                    </a:p>
                    <a:p>
                      <a:endParaRPr lang="fr-FR" sz="1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cs typeface="Times New Roman"/>
                        </a:rPr>
                        <a:t>R20, sc-648, Santa Cruz biotechnology </a:t>
                      </a:r>
                      <a:r>
                        <a:rPr lang="en-US" sz="1000" dirty="0" err="1">
                          <a:cs typeface="Times New Roman"/>
                        </a:rPr>
                        <a:t>inc</a:t>
                      </a:r>
                      <a:r>
                        <a:rPr lang="en-US" sz="1000" dirty="0">
                          <a:cs typeface="Times New Roman"/>
                        </a:rPr>
                        <a:t>, Santa Cruz, CA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6222301"/>
                  </a:ext>
                </a:extLst>
              </a:tr>
              <a:tr h="315207">
                <a:tc>
                  <a:txBody>
                    <a:bodyPr/>
                    <a:lstStyle/>
                    <a:p>
                      <a:r>
                        <a:rPr lang="en-US" sz="1000" dirty="0">
                          <a:cs typeface="Times New Roman"/>
                        </a:rPr>
                        <a:t>Endothelial Nitric Oxide Synthase/NOS3 </a:t>
                      </a:r>
                      <a:endParaRPr lang="fr-FR" sz="1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dirty="0"/>
                        <a:t>1/1000e</a:t>
                      </a:r>
                    </a:p>
                    <a:p>
                      <a:endParaRPr lang="fr-FR" sz="1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cs typeface="Times New Roman"/>
                        </a:rPr>
                        <a:t>C20, sc-654, Santa Cruz biotechnology </a:t>
                      </a:r>
                      <a:r>
                        <a:rPr lang="en-US" sz="1000" dirty="0" err="1">
                          <a:cs typeface="Times New Roman"/>
                        </a:rPr>
                        <a:t>inc</a:t>
                      </a:r>
                      <a:r>
                        <a:rPr lang="en-US" sz="1000" dirty="0">
                          <a:cs typeface="Times New Roman"/>
                        </a:rPr>
                        <a:t>, Santa Cruz, CA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40451813"/>
                  </a:ext>
                </a:extLst>
              </a:tr>
              <a:tr h="315207">
                <a:tc>
                  <a:txBody>
                    <a:bodyPr/>
                    <a:lstStyle/>
                    <a:p>
                      <a:r>
                        <a:rPr lang="en-US" sz="1000" dirty="0">
                          <a:cs typeface="Times New Roman"/>
                        </a:rPr>
                        <a:t>Actin</a:t>
                      </a:r>
                      <a:endParaRPr lang="fr-FR" sz="1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dirty="0"/>
                        <a:t>1/20000e</a:t>
                      </a:r>
                    </a:p>
                    <a:p>
                      <a:endParaRPr lang="fr-FR" sz="1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>
                          <a:cs typeface="Times New Roman"/>
                        </a:rPr>
                        <a:t>MAB 1501 </a:t>
                      </a:r>
                      <a:r>
                        <a:rPr lang="en-US" sz="1000" dirty="0" err="1">
                          <a:cs typeface="Times New Roman"/>
                        </a:rPr>
                        <a:t>Chemicon</a:t>
                      </a:r>
                      <a:r>
                        <a:rPr lang="en-US" sz="1000" dirty="0">
                          <a:cs typeface="Times New Roman"/>
                        </a:rPr>
                        <a:t> Int, Temecula, CA</a:t>
                      </a:r>
                    </a:p>
                    <a:p>
                      <a:endParaRPr lang="en-US" sz="1000" dirty="0">
                        <a:cs typeface="Times New Roman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9698378"/>
                  </a:ext>
                </a:extLst>
              </a:tr>
              <a:tr h="315207">
                <a:tc>
                  <a:txBody>
                    <a:bodyPr/>
                    <a:lstStyle/>
                    <a:p>
                      <a:r>
                        <a:rPr lang="fr-FR" sz="1000" dirty="0" err="1"/>
                        <a:t>Tomatolectin</a:t>
                      </a:r>
                      <a:endParaRPr lang="fr-FR" sz="1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fr-FR" sz="1000" dirty="0"/>
                        <a:t>1/500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>
                          <a:cs typeface="Times New Roman"/>
                        </a:rPr>
                        <a:t>Vector, Burlingame, CA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979499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064998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4">
            <a:extLst>
              <a:ext uri="{FF2B5EF4-FFF2-40B4-BE49-F238E27FC236}">
                <a16:creationId xmlns:a16="http://schemas.microsoft.com/office/drawing/2014/main" id="{940EF013-5F5B-430A-6FE0-C928ABE118E9}"/>
              </a:ext>
            </a:extLst>
          </p:cNvPr>
          <p:cNvSpPr txBox="1"/>
          <p:nvPr/>
        </p:nvSpPr>
        <p:spPr>
          <a:xfrm>
            <a:off x="492725" y="5290536"/>
            <a:ext cx="61722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cs typeface="Times New Roman" panose="02020603050405020304" pitchFamily="18" charset="0"/>
              </a:rPr>
              <a:t>Supplemental Table S3: List of primers used for real-time qPCR.</a:t>
            </a:r>
            <a:endParaRPr lang="en-US" sz="1000" dirty="0">
              <a:cs typeface="Times New Roman" panose="02020603050405020304" pitchFamily="18" charset="0"/>
            </a:endParaRPr>
          </a:p>
        </p:txBody>
      </p:sp>
      <p:graphicFrame>
        <p:nvGraphicFramePr>
          <p:cNvPr id="3" name="Tableau 2">
            <a:extLst>
              <a:ext uri="{FF2B5EF4-FFF2-40B4-BE49-F238E27FC236}">
                <a16:creationId xmlns:a16="http://schemas.microsoft.com/office/drawing/2014/main" id="{31907DE7-AA21-D66B-C8AB-C18310B32C3D}"/>
              </a:ext>
            </a:extLst>
          </p:cNvPr>
          <p:cNvGraphicFramePr>
            <a:graphicFrameLocks noGrp="1"/>
          </p:cNvGraphicFramePr>
          <p:nvPr/>
        </p:nvGraphicFramePr>
        <p:xfrm>
          <a:off x="492725" y="432472"/>
          <a:ext cx="5872550" cy="4602480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2569513">
                  <a:extLst>
                    <a:ext uri="{9D8B030D-6E8A-4147-A177-3AD203B41FA5}">
                      <a16:colId xmlns:a16="http://schemas.microsoft.com/office/drawing/2014/main" val="1999837555"/>
                    </a:ext>
                  </a:extLst>
                </a:gridCol>
                <a:gridCol w="3303037">
                  <a:extLst>
                    <a:ext uri="{9D8B030D-6E8A-4147-A177-3AD203B41FA5}">
                      <a16:colId xmlns:a16="http://schemas.microsoft.com/office/drawing/2014/main" val="502636970"/>
                    </a:ext>
                  </a:extLst>
                </a:gridCol>
              </a:tblGrid>
              <a:tr h="235456">
                <a:tc>
                  <a:txBody>
                    <a:bodyPr/>
                    <a:lstStyle/>
                    <a:p>
                      <a:r>
                        <a:rPr lang="en-US" sz="1000" dirty="0">
                          <a:cs typeface="Times New Roman"/>
                        </a:rPr>
                        <a:t>	</a:t>
                      </a:r>
                      <a:endParaRPr lang="fr-FR" sz="1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>
                          <a:cs typeface="Times New Roman"/>
                        </a:rPr>
                        <a:t>Primers</a:t>
                      </a:r>
                      <a:endParaRPr lang="fr-FR" sz="1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60575760"/>
                  </a:ext>
                </a:extLst>
              </a:tr>
              <a:tr h="315207"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dirty="0" err="1">
                          <a:cs typeface="Times New Roman"/>
                        </a:rPr>
                        <a:t>nNOS</a:t>
                      </a:r>
                      <a:r>
                        <a:rPr lang="fr-FR" sz="1000" dirty="0">
                          <a:cs typeface="Times New Roman"/>
                        </a:rPr>
                        <a:t> rattus f</a:t>
                      </a:r>
                    </a:p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dirty="0" err="1">
                          <a:cs typeface="Times New Roman"/>
                        </a:rPr>
                        <a:t>nNOS</a:t>
                      </a:r>
                      <a:r>
                        <a:rPr lang="fr-FR" sz="1000" dirty="0">
                          <a:cs typeface="Times New Roman"/>
                        </a:rPr>
                        <a:t> rattus r</a:t>
                      </a:r>
                      <a:endParaRPr lang="fr-FR" sz="1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’-</a:t>
                      </a: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GGAAACTCTCGGAGGAGGA</a:t>
                      </a:r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3’</a:t>
                      </a:r>
                    </a:p>
                    <a:p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’-</a:t>
                      </a: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GAGGGTGACCCCAAAGATG</a:t>
                      </a:r>
                      <a:r>
                        <a:rPr lang="fr-FR" sz="1000" dirty="0">
                          <a:effectLst/>
                        </a:rPr>
                        <a:t> </a:t>
                      </a:r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3’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7722358"/>
                  </a:ext>
                </a:extLst>
              </a:tr>
              <a:tr h="315207">
                <a:tc>
                  <a:txBody>
                    <a:bodyPr/>
                    <a:lstStyle/>
                    <a:p>
                      <a:r>
                        <a:rPr lang="en-US" sz="1000" dirty="0" err="1">
                          <a:cs typeface="Times New Roman"/>
                        </a:rPr>
                        <a:t>eNOS</a:t>
                      </a:r>
                      <a:r>
                        <a:rPr lang="en-US" sz="1000" dirty="0">
                          <a:cs typeface="Times New Roman"/>
                        </a:rPr>
                        <a:t> </a:t>
                      </a:r>
                      <a:r>
                        <a:rPr lang="en-US" sz="1000" dirty="0" err="1">
                          <a:cs typeface="Times New Roman"/>
                        </a:rPr>
                        <a:t>rattus</a:t>
                      </a:r>
                      <a:r>
                        <a:rPr lang="en-US" sz="1000" dirty="0">
                          <a:cs typeface="Times New Roman"/>
                        </a:rPr>
                        <a:t> f</a:t>
                      </a:r>
                    </a:p>
                    <a:p>
                      <a:r>
                        <a:rPr lang="en-US" sz="1000" dirty="0" err="1">
                          <a:cs typeface="Times New Roman"/>
                        </a:rPr>
                        <a:t>eNOS</a:t>
                      </a:r>
                      <a:r>
                        <a:rPr lang="en-US" sz="1000" dirty="0">
                          <a:cs typeface="Times New Roman"/>
                        </a:rPr>
                        <a:t> </a:t>
                      </a:r>
                      <a:r>
                        <a:rPr lang="en-US" sz="1000" dirty="0" err="1">
                          <a:cs typeface="Times New Roman"/>
                        </a:rPr>
                        <a:t>rattus</a:t>
                      </a:r>
                      <a:r>
                        <a:rPr lang="en-US" sz="1000" dirty="0">
                          <a:cs typeface="Times New Roman"/>
                        </a:rPr>
                        <a:t> r</a:t>
                      </a:r>
                      <a:endParaRPr lang="fr-FR" sz="1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’-</a:t>
                      </a: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GGCAGCCCCAAGACCTACG</a:t>
                      </a:r>
                      <a:r>
                        <a:rPr lang="fr-FR" sz="1000" dirty="0">
                          <a:effectLst/>
                        </a:rPr>
                        <a:t> </a:t>
                      </a:r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3’</a:t>
                      </a:r>
                    </a:p>
                    <a:p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’-</a:t>
                      </a: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TCCGAAAATGTCCTCGTG</a:t>
                      </a:r>
                      <a:r>
                        <a:rPr lang="fr-FR" sz="1000" dirty="0">
                          <a:effectLst/>
                        </a:rPr>
                        <a:t> </a:t>
                      </a:r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3’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6837484"/>
                  </a:ext>
                </a:extLst>
              </a:tr>
              <a:tr h="315207">
                <a:tc>
                  <a:txBody>
                    <a:bodyPr/>
                    <a:lstStyle/>
                    <a:p>
                      <a:r>
                        <a:rPr lang="en-US" sz="1000" dirty="0" err="1">
                          <a:cs typeface="Times New Roman"/>
                        </a:rPr>
                        <a:t>VEGFa</a:t>
                      </a:r>
                      <a:r>
                        <a:rPr lang="en-US" sz="1000" dirty="0">
                          <a:cs typeface="Times New Roman"/>
                        </a:rPr>
                        <a:t> </a:t>
                      </a:r>
                      <a:r>
                        <a:rPr lang="en-US" sz="1000" dirty="0" err="1">
                          <a:cs typeface="Times New Roman"/>
                        </a:rPr>
                        <a:t>rattus</a:t>
                      </a:r>
                      <a:r>
                        <a:rPr lang="en-US" sz="1000" dirty="0">
                          <a:cs typeface="Times New Roman"/>
                        </a:rPr>
                        <a:t> f</a:t>
                      </a:r>
                    </a:p>
                    <a:p>
                      <a:r>
                        <a:rPr lang="en-US" sz="1000" dirty="0" err="1">
                          <a:cs typeface="Times New Roman"/>
                        </a:rPr>
                        <a:t>VEGFa</a:t>
                      </a:r>
                      <a:r>
                        <a:rPr lang="en-US" sz="1000" dirty="0">
                          <a:cs typeface="Times New Roman"/>
                        </a:rPr>
                        <a:t> </a:t>
                      </a:r>
                      <a:r>
                        <a:rPr lang="en-US" sz="1000" dirty="0" err="1">
                          <a:cs typeface="Times New Roman"/>
                        </a:rPr>
                        <a:t>rattus</a:t>
                      </a:r>
                      <a:r>
                        <a:rPr lang="en-US" sz="1000" dirty="0">
                          <a:cs typeface="Times New Roman"/>
                        </a:rPr>
                        <a:t> r</a:t>
                      </a:r>
                      <a:endParaRPr lang="fr-FR" sz="1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’-AGGAAAGGGAAAGGGTCAAA-3’</a:t>
                      </a:r>
                    </a:p>
                    <a:p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’-AATGCTTTCTCCGCTCTGAA-3’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9055595"/>
                  </a:ext>
                </a:extLst>
              </a:tr>
              <a:tr h="315207">
                <a:tc>
                  <a:txBody>
                    <a:bodyPr/>
                    <a:lstStyle/>
                    <a:p>
                      <a:r>
                        <a:rPr lang="en-US" sz="1000" dirty="0">
                          <a:cs typeface="Times New Roman"/>
                        </a:rPr>
                        <a:t>VEGFR2 </a:t>
                      </a:r>
                      <a:r>
                        <a:rPr lang="en-US" sz="1000" dirty="0" err="1">
                          <a:cs typeface="Times New Roman"/>
                        </a:rPr>
                        <a:t>rattus</a:t>
                      </a:r>
                      <a:r>
                        <a:rPr lang="en-US" sz="1000" dirty="0">
                          <a:cs typeface="Times New Roman"/>
                        </a:rPr>
                        <a:t> f</a:t>
                      </a:r>
                    </a:p>
                    <a:p>
                      <a:r>
                        <a:rPr lang="en-US" sz="1000" dirty="0">
                          <a:cs typeface="Times New Roman"/>
                        </a:rPr>
                        <a:t>VEGFR2 </a:t>
                      </a:r>
                      <a:r>
                        <a:rPr lang="en-US" sz="1000" dirty="0" err="1">
                          <a:cs typeface="Times New Roman"/>
                        </a:rPr>
                        <a:t>rattus</a:t>
                      </a:r>
                      <a:r>
                        <a:rPr lang="en-US" sz="1000" dirty="0">
                          <a:cs typeface="Times New Roman"/>
                        </a:rPr>
                        <a:t> r</a:t>
                      </a:r>
                      <a:endParaRPr lang="fr-FR" sz="10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’-TTTGGAAGGTTGCTTGCTCT-3’</a:t>
                      </a:r>
                    </a:p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’-AGGCCAGGAGACACGTAAGA-3’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5532844"/>
                  </a:ext>
                </a:extLst>
              </a:tr>
              <a:tr h="315207">
                <a:tc>
                  <a:txBody>
                    <a:bodyPr/>
                    <a:lstStyle/>
                    <a:p>
                      <a:r>
                        <a:rPr lang="fr-FR" sz="1000" dirty="0"/>
                        <a:t>TSP1 rattus f</a:t>
                      </a:r>
                    </a:p>
                    <a:p>
                      <a:r>
                        <a:rPr lang="fr-FR" sz="1000" dirty="0"/>
                        <a:t>TSP1 rattus r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’-</a:t>
                      </a:r>
                      <a:r>
                        <a:rPr lang="fr-FR" sz="1000" u="none" strike="noStrike" dirty="0">
                          <a:effectLst/>
                        </a:rPr>
                        <a:t>GGTTTCGGAAGGTGCAAT</a:t>
                      </a:r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3’</a:t>
                      </a:r>
                    </a:p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’-</a:t>
                      </a:r>
                      <a:r>
                        <a:rPr lang="fr-FR" sz="1000" u="none" strike="noStrike" dirty="0">
                          <a:effectLst/>
                        </a:rPr>
                        <a:t>CCGGTTTGATCAGAGTGGT</a:t>
                      </a:r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3’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6174645"/>
                  </a:ext>
                </a:extLst>
              </a:tr>
              <a:tr h="315207">
                <a:tc>
                  <a:txBody>
                    <a:bodyPr/>
                    <a:lstStyle/>
                    <a:p>
                      <a:r>
                        <a:rPr lang="fr-FR" sz="1000" dirty="0"/>
                        <a:t>Tie2 rattus f</a:t>
                      </a:r>
                    </a:p>
                    <a:p>
                      <a:r>
                        <a:rPr lang="fr-FR" sz="1000" dirty="0"/>
                        <a:t>Tie2 rattus r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’-CCAGGGCTACAGATTGGAGA-3’</a:t>
                      </a:r>
                    </a:p>
                    <a:p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’- CTGGGCAAATGATGGTCTCT-3’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81254748"/>
                  </a:ext>
                </a:extLst>
              </a:tr>
              <a:tr h="315207">
                <a:tc>
                  <a:txBody>
                    <a:bodyPr/>
                    <a:lstStyle/>
                    <a:p>
                      <a:r>
                        <a:rPr lang="fr-FR" sz="1000" dirty="0"/>
                        <a:t>Krox20 rattus f</a:t>
                      </a:r>
                    </a:p>
                    <a:p>
                      <a:r>
                        <a:rPr lang="fr-FR" sz="1000" dirty="0"/>
                        <a:t>Krox30 rattus r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’-</a:t>
                      </a:r>
                      <a:r>
                        <a:rPr lang="fr-FR" sz="1000" dirty="0"/>
                        <a:t>TAGGATGCATGCAGTGGTGT</a:t>
                      </a:r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3’</a:t>
                      </a:r>
                    </a:p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’-</a:t>
                      </a:r>
                      <a:r>
                        <a:rPr lang="fr-FR" sz="1000" dirty="0"/>
                        <a:t>GCATCCTGTACACATGCAGA</a:t>
                      </a:r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3’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958962"/>
                  </a:ext>
                </a:extLst>
              </a:tr>
              <a:tr h="315207">
                <a:tc>
                  <a:txBody>
                    <a:bodyPr/>
                    <a:lstStyle/>
                    <a:p>
                      <a:r>
                        <a:rPr lang="fr-FR" sz="1000" dirty="0"/>
                        <a:t>c-</a:t>
                      </a:r>
                      <a:r>
                        <a:rPr lang="fr-FR" sz="1000" dirty="0" err="1"/>
                        <a:t>jun</a:t>
                      </a:r>
                      <a:r>
                        <a:rPr lang="fr-FR" sz="1000" dirty="0"/>
                        <a:t> rattus f</a:t>
                      </a:r>
                    </a:p>
                    <a:p>
                      <a:r>
                        <a:rPr lang="fr-FR" sz="1000" dirty="0"/>
                        <a:t>C-</a:t>
                      </a:r>
                      <a:r>
                        <a:rPr lang="fr-FR" sz="1000" dirty="0" err="1"/>
                        <a:t>jun</a:t>
                      </a:r>
                      <a:r>
                        <a:rPr lang="fr-FR" sz="1000" dirty="0"/>
                        <a:t> rattus r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u="none" strike="noStrike" dirty="0">
                          <a:effectLst/>
                        </a:rPr>
                        <a:t>5’-ACCCCCACTCAGTTCTTGTG-3’</a:t>
                      </a:r>
                      <a:endParaRPr lang="fr-FR" sz="1000" b="0" i="0" u="none" strike="noStrike" dirty="0">
                        <a:effectLst/>
                        <a:latin typeface="Verdana" panose="020B0604030504040204" pitchFamily="34" charset="0"/>
                      </a:endParaRPr>
                    </a:p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u="none" strike="noStrike" dirty="0">
                          <a:effectLst/>
                          <a:cs typeface="Times New Roman"/>
                        </a:rPr>
                        <a:t>5’-GACACTGGGCAGCGTATTCT</a:t>
                      </a:r>
                      <a:r>
                        <a:rPr lang="fr-FR" sz="1000" u="none" strike="noStrike" dirty="0">
                          <a:effectLst/>
                        </a:rPr>
                        <a:t>-3’</a:t>
                      </a:r>
                      <a:endParaRPr lang="en-US" sz="1000" dirty="0">
                        <a:cs typeface="Times New Roman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79498503"/>
                  </a:ext>
                </a:extLst>
              </a:tr>
              <a:tr h="315207">
                <a:tc>
                  <a:txBody>
                    <a:bodyPr/>
                    <a:lstStyle/>
                    <a:p>
                      <a:r>
                        <a:rPr lang="fr-FR" sz="1000" dirty="0"/>
                        <a:t>BRN2 rattus f</a:t>
                      </a:r>
                    </a:p>
                    <a:p>
                      <a:r>
                        <a:rPr lang="fr-FR" sz="1000" dirty="0"/>
                        <a:t>BRN2 rattus r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u="none" strike="noStrike" dirty="0">
                          <a:effectLst/>
                        </a:rPr>
                        <a:t>5’-CCATTTCCTCAAATGCCCTA-3’</a:t>
                      </a:r>
                      <a:endParaRPr lang="fr-FR" sz="1000" b="0" i="0" u="none" strike="noStrike" dirty="0">
                        <a:effectLst/>
                        <a:latin typeface="Verdana" panose="020B0604030504040204" pitchFamily="34" charset="0"/>
                      </a:endParaRPr>
                    </a:p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u="none" strike="noStrike" dirty="0">
                          <a:effectLst/>
                          <a:cs typeface="Times New Roman"/>
                        </a:rPr>
                        <a:t>5’-</a:t>
                      </a:r>
                      <a:r>
                        <a:rPr lang="fr-FR" sz="1000" u="none" strike="noStrike" dirty="0">
                          <a:effectLst/>
                        </a:rPr>
                        <a:t>GGAGGGGTCATCCTTTTCTC-3’</a:t>
                      </a:r>
                      <a:endParaRPr lang="en-US" sz="1000" dirty="0">
                        <a:cs typeface="Times New Roman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52511010"/>
                  </a:ext>
                </a:extLst>
              </a:tr>
              <a:tr h="315207">
                <a:tc>
                  <a:txBody>
                    <a:bodyPr/>
                    <a:lstStyle/>
                    <a:p>
                      <a:r>
                        <a:rPr lang="fr-FR" sz="1000" dirty="0"/>
                        <a:t>Ang1 rattus f</a:t>
                      </a:r>
                    </a:p>
                    <a:p>
                      <a:r>
                        <a:rPr lang="fr-FR" sz="1000" dirty="0"/>
                        <a:t>Ang1 rattus r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u="none" strike="noStrike" dirty="0">
                          <a:effectLst/>
                        </a:rPr>
                        <a:t>5’-GAG CCT GCC TCC TCT GTT G-3’</a:t>
                      </a:r>
                      <a:endParaRPr lang="fr-FR" sz="1000" b="0" i="0" u="none" strike="noStrike" dirty="0">
                        <a:effectLst/>
                        <a:latin typeface="Verdana" panose="020B0604030504040204" pitchFamily="34" charset="0"/>
                      </a:endParaRPr>
                    </a:p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u="none" strike="noStrike" dirty="0">
                          <a:effectLst/>
                          <a:cs typeface="Times New Roman"/>
                        </a:rPr>
                        <a:t>5’-</a:t>
                      </a:r>
                      <a:r>
                        <a:rPr lang="fr-FR" sz="1000" u="none" strike="noStrike" dirty="0">
                          <a:effectLst/>
                        </a:rPr>
                        <a:t>CCT TGA TGC TGC CCT TGT T-3’</a:t>
                      </a:r>
                      <a:endParaRPr lang="fr-FR" sz="1000" b="0" i="0" u="none" strike="noStrike" dirty="0">
                        <a:effectLst/>
                        <a:latin typeface="Verdana" panose="020B060403050404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67658364"/>
                  </a:ext>
                </a:extLst>
              </a:tr>
              <a:tr h="315207">
                <a:tc>
                  <a:txBody>
                    <a:bodyPr/>
                    <a:lstStyle/>
                    <a:p>
                      <a:r>
                        <a:rPr lang="fr-FR" sz="1000" dirty="0"/>
                        <a:t>ANGPT1 rattus f</a:t>
                      </a:r>
                    </a:p>
                    <a:p>
                      <a:r>
                        <a:rPr lang="fr-FR" sz="1000" dirty="0"/>
                        <a:t>ANGPT1 rattus r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’-CAGCACAAAGGACGCTGATA-3’</a:t>
                      </a:r>
                    </a:p>
                    <a:p>
                      <a:r>
                        <a:rPr lang="fr-FR" sz="10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’- TTAGATTGGAAGGGCCACAG-3’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7869210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109052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e 21">
            <a:extLst>
              <a:ext uri="{FF2B5EF4-FFF2-40B4-BE49-F238E27FC236}">
                <a16:creationId xmlns:a16="http://schemas.microsoft.com/office/drawing/2014/main" id="{DEE0D3E4-1B8F-E232-6942-9520AD30DB26}"/>
              </a:ext>
            </a:extLst>
          </p:cNvPr>
          <p:cNvGrpSpPr/>
          <p:nvPr/>
        </p:nvGrpSpPr>
        <p:grpSpPr>
          <a:xfrm>
            <a:off x="642796" y="1556232"/>
            <a:ext cx="5807798" cy="4278991"/>
            <a:chOff x="642796" y="1556232"/>
            <a:chExt cx="5807798" cy="4278991"/>
          </a:xfrm>
        </p:grpSpPr>
        <p:pic>
          <p:nvPicPr>
            <p:cNvPr id="5" name="Image 4">
              <a:extLst>
                <a:ext uri="{FF2B5EF4-FFF2-40B4-BE49-F238E27FC236}">
                  <a16:creationId xmlns:a16="http://schemas.microsoft.com/office/drawing/2014/main" id="{7D65FA5C-C29C-0845-A6DD-D9C7DEF5B34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42796" y="1556232"/>
              <a:ext cx="5807798" cy="3294127"/>
            </a:xfrm>
            <a:prstGeom prst="rect">
              <a:avLst/>
            </a:prstGeom>
          </p:spPr>
        </p:pic>
        <p:sp>
          <p:nvSpPr>
            <p:cNvPr id="4" name="TextBox 14">
              <a:extLst>
                <a:ext uri="{FF2B5EF4-FFF2-40B4-BE49-F238E27FC236}">
                  <a16:creationId xmlns:a16="http://schemas.microsoft.com/office/drawing/2014/main" id="{9CB3D6C5-231F-1D32-C3B0-6BB2E921E76B}"/>
                </a:ext>
              </a:extLst>
            </p:cNvPr>
            <p:cNvSpPr txBox="1"/>
            <p:nvPr/>
          </p:nvSpPr>
          <p:spPr>
            <a:xfrm>
              <a:off x="642796" y="5127337"/>
              <a:ext cx="5601696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000" b="1" dirty="0">
                  <a:cs typeface="Times New Roman" panose="02020603050405020304" pitchFamily="18" charset="0"/>
                </a:rPr>
                <a:t>Supplemental Figure S1. </a:t>
              </a:r>
              <a:r>
                <a:rPr lang="en-US" sz="1000" b="1" dirty="0">
                  <a:ea typeface="Calibri" panose="020F0502020204030204" pitchFamily="34" charset="0"/>
                  <a:cs typeface="Times New Roman" panose="02020603050405020304" pitchFamily="18" charset="0"/>
                </a:rPr>
                <a:t>Inhaled NO reverses the growth failure associated with L-Name exposure  in rat pups.</a:t>
              </a:r>
            </a:p>
            <a:p>
              <a:pPr algn="just"/>
              <a:r>
                <a:rPr lang="en-US" sz="1000" dirty="0">
                  <a:cs typeface="Times New Roman" panose="02020603050405020304" pitchFamily="18" charset="0"/>
                </a:rPr>
                <a:t>Two-way ANOVA and Tukey post hoc test: * and *** compared to </a:t>
              </a:r>
              <a:r>
                <a:rPr lang="en-US" sz="1000" dirty="0" err="1">
                  <a:cs typeface="Times New Roman" panose="02020603050405020304" pitchFamily="18" charset="0"/>
                </a:rPr>
                <a:t>Ctl</a:t>
              </a:r>
              <a:r>
                <a:rPr lang="en-US" sz="1000" dirty="0">
                  <a:cs typeface="Times New Roman" panose="02020603050405020304" pitchFamily="18" charset="0"/>
                </a:rPr>
                <a:t> means p &lt;0.05 and &lt;0.001, respectively.</a:t>
              </a:r>
            </a:p>
          </p:txBody>
        </p:sp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id="{0011F3B1-E396-35E4-8F4A-447B84120916}"/>
                </a:ext>
              </a:extLst>
            </p:cNvPr>
            <p:cNvSpPr txBox="1"/>
            <p:nvPr/>
          </p:nvSpPr>
          <p:spPr>
            <a:xfrm>
              <a:off x="1525939" y="1587951"/>
              <a:ext cx="1277914" cy="79182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>
                <a:lnSpc>
                  <a:spcPts val="1400"/>
                </a:lnSpc>
              </a:pPr>
              <a:r>
                <a:rPr lang="fr-F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ts val="1400"/>
                </a:lnSpc>
              </a:pPr>
              <a:r>
                <a:rPr lang="fr-FR" sz="900" dirty="0">
                  <a:latin typeface="Arial" panose="020B0604020202020204" pitchFamily="34" charset="0"/>
                  <a:cs typeface="Arial" panose="020B0604020202020204" pitchFamily="34" charset="0"/>
                </a:rPr>
                <a:t>NO 5 ppm</a:t>
              </a:r>
            </a:p>
            <a:p>
              <a:pPr>
                <a:lnSpc>
                  <a:spcPts val="1400"/>
                </a:lnSpc>
              </a:pPr>
              <a:r>
                <a:rPr lang="fr-FR" sz="900" dirty="0">
                  <a:latin typeface="Arial" panose="020B0604020202020204" pitchFamily="34" charset="0"/>
                  <a:cs typeface="Arial" panose="020B0604020202020204" pitchFamily="34" charset="0"/>
                </a:rPr>
                <a:t>L-NAME</a:t>
              </a:r>
            </a:p>
            <a:p>
              <a:pPr>
                <a:lnSpc>
                  <a:spcPts val="1400"/>
                </a:lnSpc>
              </a:pPr>
              <a:r>
                <a:rPr lang="fr-FR" sz="900" dirty="0">
                  <a:latin typeface="Arial" panose="020B0604020202020204" pitchFamily="34" charset="0"/>
                  <a:cs typeface="Arial" panose="020B0604020202020204" pitchFamily="34" charset="0"/>
                </a:rPr>
                <a:t>L-NAME + NO 5 ppm</a:t>
              </a:r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7D6E3607-82A3-F16F-934E-35953535B8F5}"/>
                </a:ext>
              </a:extLst>
            </p:cNvPr>
            <p:cNvSpPr/>
            <p:nvPr/>
          </p:nvSpPr>
          <p:spPr>
            <a:xfrm>
              <a:off x="1256998" y="3432030"/>
              <a:ext cx="212315" cy="9650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A809080C-A66C-1FFA-DC54-D602FADC80DC}"/>
                </a:ext>
              </a:extLst>
            </p:cNvPr>
            <p:cNvSpPr/>
            <p:nvPr/>
          </p:nvSpPr>
          <p:spPr>
            <a:xfrm>
              <a:off x="1889522" y="3425194"/>
              <a:ext cx="212315" cy="9650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A5862FA2-10DF-5874-FD24-C4FE60515970}"/>
                </a:ext>
              </a:extLst>
            </p:cNvPr>
            <p:cNvSpPr/>
            <p:nvPr/>
          </p:nvSpPr>
          <p:spPr>
            <a:xfrm>
              <a:off x="2555824" y="3268770"/>
              <a:ext cx="212315" cy="9650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326E8967-F634-F0DD-4FDA-E8790A11373D}"/>
                </a:ext>
              </a:extLst>
            </p:cNvPr>
            <p:cNvSpPr/>
            <p:nvPr/>
          </p:nvSpPr>
          <p:spPr>
            <a:xfrm>
              <a:off x="3156982" y="3076157"/>
              <a:ext cx="212315" cy="9650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8205A2CC-E53D-41AA-F65D-BBD6E72595F0}"/>
                </a:ext>
              </a:extLst>
            </p:cNvPr>
            <p:cNvSpPr/>
            <p:nvPr/>
          </p:nvSpPr>
          <p:spPr>
            <a:xfrm>
              <a:off x="3854648" y="2738783"/>
              <a:ext cx="212315" cy="9650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CF5F0590-51BD-8E9D-243F-FCF6563E7427}"/>
                </a:ext>
              </a:extLst>
            </p:cNvPr>
            <p:cNvSpPr/>
            <p:nvPr/>
          </p:nvSpPr>
          <p:spPr>
            <a:xfrm>
              <a:off x="4484757" y="2442425"/>
              <a:ext cx="212315" cy="9650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CCDBFB90-EA19-E192-596B-4AD7871788EE}"/>
                </a:ext>
              </a:extLst>
            </p:cNvPr>
            <p:cNvSpPr/>
            <p:nvPr/>
          </p:nvSpPr>
          <p:spPr>
            <a:xfrm>
              <a:off x="5110042" y="2225686"/>
              <a:ext cx="212315" cy="9650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595B20DB-CAB7-D0DF-C901-71DAEEE65F74}"/>
                </a:ext>
              </a:extLst>
            </p:cNvPr>
            <p:cNvSpPr/>
            <p:nvPr/>
          </p:nvSpPr>
          <p:spPr>
            <a:xfrm>
              <a:off x="5759454" y="1943804"/>
              <a:ext cx="212315" cy="9650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6F2BFE36-C39A-E650-170B-DDC9BE0822D2}"/>
                </a:ext>
              </a:extLst>
            </p:cNvPr>
            <p:cNvSpPr txBox="1"/>
            <p:nvPr/>
          </p:nvSpPr>
          <p:spPr>
            <a:xfrm>
              <a:off x="1324553" y="3591267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/>
                <a:t>*</a:t>
              </a: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0752E1BC-7310-11D9-07FE-F4D9466EB5E2}"/>
                </a:ext>
              </a:extLst>
            </p:cNvPr>
            <p:cNvSpPr txBox="1"/>
            <p:nvPr/>
          </p:nvSpPr>
          <p:spPr>
            <a:xfrm>
              <a:off x="1918477" y="3593298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/>
                <a:t>***</a:t>
              </a:r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2CA28F1E-7682-6221-1612-295BF56D4BAB}"/>
                </a:ext>
              </a:extLst>
            </p:cNvPr>
            <p:cNvSpPr txBox="1"/>
            <p:nvPr/>
          </p:nvSpPr>
          <p:spPr>
            <a:xfrm>
              <a:off x="2558240" y="3567155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/>
                <a:t>***</a:t>
              </a:r>
            </a:p>
          </p:txBody>
        </p: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125D8918-AD07-5AB2-0D36-645D0C20B317}"/>
                </a:ext>
              </a:extLst>
            </p:cNvPr>
            <p:cNvSpPr txBox="1"/>
            <p:nvPr/>
          </p:nvSpPr>
          <p:spPr>
            <a:xfrm>
              <a:off x="3200414" y="342521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/>
                <a:t>***</a:t>
              </a:r>
            </a:p>
          </p:txBody>
        </p:sp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786F1B2E-7B3F-5190-4C2F-56866C10682F}"/>
                </a:ext>
              </a:extLst>
            </p:cNvPr>
            <p:cNvSpPr txBox="1"/>
            <p:nvPr/>
          </p:nvSpPr>
          <p:spPr>
            <a:xfrm>
              <a:off x="3840173" y="3312218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/>
                <a:t>***</a:t>
              </a: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538A8123-EE03-883D-C687-DFEACDAACA05}"/>
                </a:ext>
              </a:extLst>
            </p:cNvPr>
            <p:cNvSpPr txBox="1"/>
            <p:nvPr/>
          </p:nvSpPr>
          <p:spPr>
            <a:xfrm>
              <a:off x="4477522" y="3114777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/>
                <a:t>***</a:t>
              </a:r>
            </a:p>
          </p:txBody>
        </p:sp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E082B338-6FD9-0D74-9FB4-A408C6BFC871}"/>
                </a:ext>
              </a:extLst>
            </p:cNvPr>
            <p:cNvSpPr txBox="1"/>
            <p:nvPr/>
          </p:nvSpPr>
          <p:spPr>
            <a:xfrm>
              <a:off x="5114872" y="2953530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/>
                <a:t>***</a:t>
              </a:r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13B47FC4-E9AF-3FFB-0D49-F25822465E34}"/>
                </a:ext>
              </a:extLst>
            </p:cNvPr>
            <p:cNvSpPr txBox="1"/>
            <p:nvPr/>
          </p:nvSpPr>
          <p:spPr>
            <a:xfrm>
              <a:off x="5759461" y="2727141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/>
                <a:t>**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915008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4">
            <a:extLst>
              <a:ext uri="{FF2B5EF4-FFF2-40B4-BE49-F238E27FC236}">
                <a16:creationId xmlns:a16="http://schemas.microsoft.com/office/drawing/2014/main" id="{E6C52CDF-F14A-EAF1-450D-6FCA310EDC40}"/>
              </a:ext>
            </a:extLst>
          </p:cNvPr>
          <p:cNvSpPr txBox="1"/>
          <p:nvPr/>
        </p:nvSpPr>
        <p:spPr>
          <a:xfrm>
            <a:off x="501888" y="3451391"/>
            <a:ext cx="55802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cs typeface="Times New Roman" panose="02020603050405020304" pitchFamily="18" charset="0"/>
              </a:rPr>
              <a:t>Supplemental Figure S2. </a:t>
            </a:r>
            <a:r>
              <a:rPr lang="en-US" sz="1000" dirty="0">
                <a:cs typeface="Times New Roman" panose="02020603050405020304" pitchFamily="18" charset="0"/>
              </a:rPr>
              <a:t>Comparison of gene expression of factors recognized to control brain angiogenesis, assessed using qPCR, between room air- and iNO-exposed rat pups at P7.</a:t>
            </a:r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89220401-13F3-03F6-784D-7F8D8934A1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1888" y="803592"/>
            <a:ext cx="5580296" cy="2401084"/>
          </a:xfrm>
          <a:prstGeom prst="rect">
            <a:avLst/>
          </a:prstGeom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5E5A506B-4FEE-93C7-D2CE-B0804B38ECFA}"/>
              </a:ext>
            </a:extLst>
          </p:cNvPr>
          <p:cNvSpPr txBox="1"/>
          <p:nvPr/>
        </p:nvSpPr>
        <p:spPr>
          <a:xfrm>
            <a:off x="535081" y="556877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A</a:t>
            </a:r>
            <a:endParaRPr lang="fr-FR" dirty="0"/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DA38C016-152D-055F-8494-6D19CF81C121}"/>
              </a:ext>
            </a:extLst>
          </p:cNvPr>
          <p:cNvSpPr txBox="1"/>
          <p:nvPr/>
        </p:nvSpPr>
        <p:spPr>
          <a:xfrm>
            <a:off x="2426028" y="556876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B</a:t>
            </a:r>
            <a:endParaRPr lang="fr-FR" dirty="0"/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32577713-FDB8-F62F-D1A7-C479E4B1771F}"/>
              </a:ext>
            </a:extLst>
          </p:cNvPr>
          <p:cNvSpPr txBox="1"/>
          <p:nvPr/>
        </p:nvSpPr>
        <p:spPr>
          <a:xfrm>
            <a:off x="4365706" y="556876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C</a:t>
            </a:r>
            <a:endParaRPr lang="fr-FR" dirty="0"/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573B0F89-0B6D-9723-9FD9-AF5FA194390D}"/>
              </a:ext>
            </a:extLst>
          </p:cNvPr>
          <p:cNvSpPr txBox="1"/>
          <p:nvPr/>
        </p:nvSpPr>
        <p:spPr>
          <a:xfrm>
            <a:off x="527044" y="1939621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D</a:t>
            </a:r>
            <a:endParaRPr lang="fr-FR" dirty="0"/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C2CA49B9-40FF-7323-002F-DD53876D5432}"/>
              </a:ext>
            </a:extLst>
          </p:cNvPr>
          <p:cNvSpPr txBox="1"/>
          <p:nvPr/>
        </p:nvSpPr>
        <p:spPr>
          <a:xfrm>
            <a:off x="2426028" y="1939627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E</a:t>
            </a:r>
            <a:endParaRPr lang="fr-FR" dirty="0"/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01F6BF2D-784D-B9B2-8304-51275A30B104}"/>
              </a:ext>
            </a:extLst>
          </p:cNvPr>
          <p:cNvSpPr txBox="1"/>
          <p:nvPr/>
        </p:nvSpPr>
        <p:spPr>
          <a:xfrm>
            <a:off x="4354036" y="1939621"/>
            <a:ext cx="2664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F</a:t>
            </a:r>
            <a:endParaRPr lang="fr-FR" dirty="0"/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786E3FA5-9AA7-C9FB-F717-A4CA386F8E6B}"/>
              </a:ext>
            </a:extLst>
          </p:cNvPr>
          <p:cNvSpPr txBox="1"/>
          <p:nvPr/>
        </p:nvSpPr>
        <p:spPr>
          <a:xfrm>
            <a:off x="1292660" y="1792287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/>
              <a:t>Tie2</a:t>
            </a:r>
            <a:endParaRPr lang="fr-FR" dirty="0"/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5B879125-33A8-D75C-049D-398909B621DA}"/>
              </a:ext>
            </a:extLst>
          </p:cNvPr>
          <p:cNvSpPr txBox="1"/>
          <p:nvPr/>
        </p:nvSpPr>
        <p:spPr>
          <a:xfrm>
            <a:off x="3166372" y="1793105"/>
            <a:ext cx="51007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/>
              <a:t>Krox20</a:t>
            </a:r>
            <a:endParaRPr lang="fr-FR" dirty="0"/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F5946493-2A09-1C4D-49FD-B00BD63CC192}"/>
              </a:ext>
            </a:extLst>
          </p:cNvPr>
          <p:cNvSpPr txBox="1"/>
          <p:nvPr/>
        </p:nvSpPr>
        <p:spPr>
          <a:xfrm>
            <a:off x="5166723" y="1773302"/>
            <a:ext cx="3818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err="1"/>
              <a:t>cjun</a:t>
            </a:r>
            <a:endParaRPr lang="fr-FR" dirty="0"/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19358F97-2607-1C98-3F94-2B5834F6EA73}"/>
              </a:ext>
            </a:extLst>
          </p:cNvPr>
          <p:cNvSpPr txBox="1"/>
          <p:nvPr/>
        </p:nvSpPr>
        <p:spPr>
          <a:xfrm>
            <a:off x="1306305" y="3125506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/>
              <a:t>BRN2</a:t>
            </a:r>
            <a:endParaRPr lang="fr-FR" dirty="0"/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D9ABE1C6-F681-D5FD-F7FA-FE2E476D1074}"/>
              </a:ext>
            </a:extLst>
          </p:cNvPr>
          <p:cNvSpPr txBox="1"/>
          <p:nvPr/>
        </p:nvSpPr>
        <p:spPr>
          <a:xfrm>
            <a:off x="3016491" y="3125506"/>
            <a:ext cx="80983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/>
              <a:t>Angiogenin-1</a:t>
            </a:r>
            <a:endParaRPr lang="fr-FR" dirty="0"/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E8F7DE98-E546-F72D-1657-81DF2D8C5BB5}"/>
              </a:ext>
            </a:extLst>
          </p:cNvPr>
          <p:cNvSpPr txBox="1"/>
          <p:nvPr/>
        </p:nvSpPr>
        <p:spPr>
          <a:xfrm>
            <a:off x="4963141" y="3125506"/>
            <a:ext cx="7889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err="1"/>
              <a:t>Angiopoietin</a:t>
            </a:r>
            <a:endParaRPr lang="fr-FR" dirty="0"/>
          </a:p>
        </p:txBody>
      </p:sp>
      <p:grpSp>
        <p:nvGrpSpPr>
          <p:cNvPr id="3" name="Groupe 2">
            <a:extLst>
              <a:ext uri="{FF2B5EF4-FFF2-40B4-BE49-F238E27FC236}">
                <a16:creationId xmlns:a16="http://schemas.microsoft.com/office/drawing/2014/main" id="{4BC8ED4C-355C-D41F-C6E0-B66DBC3575B9}"/>
              </a:ext>
            </a:extLst>
          </p:cNvPr>
          <p:cNvGrpSpPr/>
          <p:nvPr/>
        </p:nvGrpSpPr>
        <p:grpSpPr>
          <a:xfrm>
            <a:off x="964294" y="610730"/>
            <a:ext cx="684022" cy="338203"/>
            <a:chOff x="-2004874" y="5303542"/>
            <a:chExt cx="684022" cy="338203"/>
          </a:xfrm>
        </p:grpSpPr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17695B8A-C420-CFE4-6B44-3B942A9B4ADA}"/>
                </a:ext>
              </a:extLst>
            </p:cNvPr>
            <p:cNvSpPr/>
            <p:nvPr/>
          </p:nvSpPr>
          <p:spPr>
            <a:xfrm>
              <a:off x="-2004874" y="5368079"/>
              <a:ext cx="140826" cy="877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BA53C577-722D-2953-64C7-FD123BC9E31E}"/>
                </a:ext>
              </a:extLst>
            </p:cNvPr>
            <p:cNvSpPr/>
            <p:nvPr/>
          </p:nvSpPr>
          <p:spPr>
            <a:xfrm>
              <a:off x="-1998947" y="5491727"/>
              <a:ext cx="140826" cy="8459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33D23B6C-640B-5656-447D-AAC49458C01F}"/>
                </a:ext>
              </a:extLst>
            </p:cNvPr>
            <p:cNvSpPr txBox="1"/>
            <p:nvPr/>
          </p:nvSpPr>
          <p:spPr>
            <a:xfrm>
              <a:off x="-1934461" y="5303542"/>
              <a:ext cx="2968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err="1"/>
                <a:t>Ctl</a:t>
              </a:r>
              <a:endParaRPr lang="fr-FR" dirty="0"/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418B2553-A7C2-6287-590C-31A16EBC7455}"/>
                </a:ext>
              </a:extLst>
            </p:cNvPr>
            <p:cNvSpPr txBox="1"/>
            <p:nvPr/>
          </p:nvSpPr>
          <p:spPr>
            <a:xfrm>
              <a:off x="-1925505" y="5426301"/>
              <a:ext cx="60465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NO 5 pp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450479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14">
            <a:extLst>
              <a:ext uri="{FF2B5EF4-FFF2-40B4-BE49-F238E27FC236}">
                <a16:creationId xmlns:a16="http://schemas.microsoft.com/office/drawing/2014/main" id="{669083A2-2BB3-1E03-1C0B-B0D2BC10486F}"/>
              </a:ext>
            </a:extLst>
          </p:cNvPr>
          <p:cNvSpPr txBox="1"/>
          <p:nvPr/>
        </p:nvSpPr>
        <p:spPr>
          <a:xfrm>
            <a:off x="461320" y="5315324"/>
            <a:ext cx="552758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cs typeface="Times New Roman" panose="02020603050405020304" pitchFamily="18" charset="0"/>
              </a:rPr>
              <a:t>Supplemental Figure S3. S</a:t>
            </a:r>
            <a:r>
              <a:rPr lang="en-US" sz="1000" b="1" dirty="0">
                <a:ea typeface="Calibri" panose="020F0502020204030204" pitchFamily="34" charset="0"/>
                <a:cs typeface="Times New Roman" panose="02020603050405020304" pitchFamily="18" charset="0"/>
              </a:rPr>
              <a:t>chematic representation of soluble guanylate cyclase/cGMP pathway leading to intracellular effects of exogenous inhaled NO.</a:t>
            </a:r>
          </a:p>
          <a:p>
            <a:pPr algn="just"/>
            <a:r>
              <a:rPr lang="en-US" sz="10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iNO is remotely delivered to </a:t>
            </a:r>
            <a:r>
              <a:rPr lang="en-US" sz="10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the endothelial cells of the developing brain using </a:t>
            </a:r>
            <a:r>
              <a:rPr lang="en-US" sz="10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blood carriers. Diffusing into the cytoplasm, iNO promotes angiogenesis binding to the soluble Guanylate Cyclase (</a:t>
            </a:r>
            <a:r>
              <a:rPr lang="en-US" sz="1000" dirty="0" err="1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sGC</a:t>
            </a:r>
            <a:r>
              <a:rPr lang="en-US" sz="10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), modulating cGMP production and down-regulating TSP-1 expression.  </a:t>
            </a:r>
            <a:endParaRPr lang="fr-FR" sz="1000" dirty="0">
              <a:solidFill>
                <a:srgbClr val="000000"/>
              </a:solidFill>
              <a:effectLst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sz="1000" dirty="0">
              <a:cs typeface="Times New Roman" panose="02020603050405020304" pitchFamily="18" charset="0"/>
            </a:endParaRP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E8D96AE5-63DD-E4AC-A71E-994A97837E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95375"/>
            <a:ext cx="6858000" cy="38576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136293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344</TotalTime>
  <Words>610</Words>
  <Application>Microsoft Macintosh PowerPoint</Application>
  <PresentationFormat>Format A4 (210 x 297 mm)</PresentationFormat>
  <Paragraphs>146</Paragraphs>
  <Slides>6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Verdana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authier LORON</dc:creator>
  <cp:lastModifiedBy>Gauthier LORON</cp:lastModifiedBy>
  <cp:revision>5</cp:revision>
  <dcterms:created xsi:type="dcterms:W3CDTF">2023-01-25T16:24:45Z</dcterms:created>
  <dcterms:modified xsi:type="dcterms:W3CDTF">2023-03-12T10:23:16Z</dcterms:modified>
</cp:coreProperties>
</file>